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255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893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558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140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660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174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940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985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504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265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177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046718-6EE7-44F3-B042-469DA2828976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D7E5C-9B30-429D-99B2-3546884B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678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6" name="Group 175"/>
          <p:cNvGrpSpPr/>
          <p:nvPr/>
        </p:nvGrpSpPr>
        <p:grpSpPr>
          <a:xfrm>
            <a:off x="220262" y="654850"/>
            <a:ext cx="6473718" cy="2847923"/>
            <a:chOff x="220262" y="654850"/>
            <a:chExt cx="6473718" cy="2847923"/>
          </a:xfrm>
        </p:grpSpPr>
        <p:sp>
          <p:nvSpPr>
            <p:cNvPr id="80" name="TextBox 79"/>
            <p:cNvSpPr txBox="1"/>
            <p:nvPr/>
          </p:nvSpPr>
          <p:spPr>
            <a:xfrm>
              <a:off x="220262" y="2579443"/>
              <a:ext cx="6406626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l figure 1: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atment of cells with e5 SEV for 16 hours does not affect cellular viability.  Five recipients were 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ested, error bars indicate standard deviation for technical replicates 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Monocyte-derived DCs were mock treated or treated with 10</a:t>
              </a:r>
              <a:r>
                <a:rPr lang="en-US" sz="9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EV overnight.  Cells were stained with live-dead viability stain, fixed, and analyzed by flow cytometry.  Cells are gated on high SSC DCs and the percent of live (unstained) cells are plotted on the y-axis.  (B) Negatively selected T cells were mock treated or treated with 10</a:t>
              </a:r>
              <a:r>
                <a:rPr lang="en-US" sz="9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V overnight.  Cells were stained with live-dead viability stain, fixed, stained with an anti-CD3 antibody and analyzed by flow cytometry.  The percent of live CD3+ cells is plotted. </a:t>
              </a:r>
              <a:endParaRPr 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3" name="Group 172"/>
            <p:cNvGrpSpPr/>
            <p:nvPr/>
          </p:nvGrpSpPr>
          <p:grpSpPr>
            <a:xfrm>
              <a:off x="270558" y="654850"/>
              <a:ext cx="6423422" cy="1874246"/>
              <a:chOff x="34421" y="5573520"/>
              <a:chExt cx="6423422" cy="1874246"/>
            </a:xfrm>
          </p:grpSpPr>
          <p:grpSp>
            <p:nvGrpSpPr>
              <p:cNvPr id="168" name="Group 167"/>
              <p:cNvGrpSpPr/>
              <p:nvPr/>
            </p:nvGrpSpPr>
            <p:grpSpPr>
              <a:xfrm>
                <a:off x="247650" y="5573520"/>
                <a:ext cx="2390776" cy="1873985"/>
                <a:chOff x="247650" y="5573520"/>
                <a:chExt cx="2390776" cy="1873985"/>
              </a:xfrm>
            </p:grpSpPr>
            <p:sp>
              <p:nvSpPr>
                <p:cNvPr id="5" name="Rectangle 5"/>
                <p:cNvSpPr>
                  <a:spLocks noChangeArrowheads="1"/>
                </p:cNvSpPr>
                <p:nvPr/>
              </p:nvSpPr>
              <p:spPr bwMode="auto">
                <a:xfrm>
                  <a:off x="804863" y="5878513"/>
                  <a:ext cx="107950" cy="1076325"/>
                </a:xfrm>
                <a:prstGeom prst="rect">
                  <a:avLst/>
                </a:prstGeom>
                <a:solidFill>
                  <a:srgbClr val="A0A0A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" name="Freeform 6"/>
                <p:cNvSpPr>
                  <a:spLocks/>
                </p:cNvSpPr>
                <p:nvPr/>
              </p:nvSpPr>
              <p:spPr bwMode="auto">
                <a:xfrm>
                  <a:off x="790575" y="5878513"/>
                  <a:ext cx="136525" cy="1076325"/>
                </a:xfrm>
                <a:custGeom>
                  <a:avLst/>
                  <a:gdLst>
                    <a:gd name="T0" fmla="*/ 17 w 170"/>
                    <a:gd name="T1" fmla="*/ 1356 h 1356"/>
                    <a:gd name="T2" fmla="*/ 17 w 170"/>
                    <a:gd name="T3" fmla="*/ 0 h 1356"/>
                    <a:gd name="T4" fmla="*/ 0 w 170"/>
                    <a:gd name="T5" fmla="*/ 0 h 1356"/>
                    <a:gd name="T6" fmla="*/ 170 w 170"/>
                    <a:gd name="T7" fmla="*/ 0 h 1356"/>
                    <a:gd name="T8" fmla="*/ 153 w 170"/>
                    <a:gd name="T9" fmla="*/ 0 h 1356"/>
                    <a:gd name="T10" fmla="*/ 153 w 170"/>
                    <a:gd name="T11" fmla="*/ 1356 h 13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0" h="1356">
                      <a:moveTo>
                        <a:pt x="17" y="1356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0" y="0"/>
                      </a:lnTo>
                      <a:lnTo>
                        <a:pt x="153" y="0"/>
                      </a:lnTo>
                      <a:lnTo>
                        <a:pt x="153" y="1356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" name="Rectangle 7"/>
                <p:cNvSpPr>
                  <a:spLocks noChangeArrowheads="1"/>
                </p:cNvSpPr>
                <p:nvPr/>
              </p:nvSpPr>
              <p:spPr bwMode="auto">
                <a:xfrm>
                  <a:off x="1212850" y="5895976"/>
                  <a:ext cx="107950" cy="1058863"/>
                </a:xfrm>
                <a:prstGeom prst="rect">
                  <a:avLst/>
                </a:prstGeom>
                <a:solidFill>
                  <a:srgbClr val="A0A0A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" name="Freeform 8"/>
                <p:cNvSpPr>
                  <a:spLocks/>
                </p:cNvSpPr>
                <p:nvPr/>
              </p:nvSpPr>
              <p:spPr bwMode="auto">
                <a:xfrm>
                  <a:off x="1200150" y="5895976"/>
                  <a:ext cx="134938" cy="1058863"/>
                </a:xfrm>
                <a:custGeom>
                  <a:avLst/>
                  <a:gdLst>
                    <a:gd name="T0" fmla="*/ 17 w 171"/>
                    <a:gd name="T1" fmla="*/ 1335 h 1335"/>
                    <a:gd name="T2" fmla="*/ 17 w 171"/>
                    <a:gd name="T3" fmla="*/ 0 h 1335"/>
                    <a:gd name="T4" fmla="*/ 0 w 171"/>
                    <a:gd name="T5" fmla="*/ 0 h 1335"/>
                    <a:gd name="T6" fmla="*/ 171 w 171"/>
                    <a:gd name="T7" fmla="*/ 0 h 1335"/>
                    <a:gd name="T8" fmla="*/ 154 w 171"/>
                    <a:gd name="T9" fmla="*/ 0 h 1335"/>
                    <a:gd name="T10" fmla="*/ 154 w 171"/>
                    <a:gd name="T11" fmla="*/ 1335 h 13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1" h="1335">
                      <a:moveTo>
                        <a:pt x="17" y="1335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1" y="0"/>
                      </a:lnTo>
                      <a:lnTo>
                        <a:pt x="154" y="0"/>
                      </a:lnTo>
                      <a:lnTo>
                        <a:pt x="154" y="1335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4" name="Rectangle 9"/>
                <p:cNvSpPr>
                  <a:spLocks noChangeArrowheads="1"/>
                </p:cNvSpPr>
                <p:nvPr/>
              </p:nvSpPr>
              <p:spPr bwMode="auto">
                <a:xfrm>
                  <a:off x="1622425" y="5983288"/>
                  <a:ext cx="107950" cy="971550"/>
                </a:xfrm>
                <a:prstGeom prst="rect">
                  <a:avLst/>
                </a:prstGeom>
                <a:solidFill>
                  <a:srgbClr val="A0A0A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5" name="Freeform 10"/>
                <p:cNvSpPr>
                  <a:spLocks/>
                </p:cNvSpPr>
                <p:nvPr/>
              </p:nvSpPr>
              <p:spPr bwMode="auto">
                <a:xfrm>
                  <a:off x="1608138" y="5983288"/>
                  <a:ext cx="134938" cy="971550"/>
                </a:xfrm>
                <a:custGeom>
                  <a:avLst/>
                  <a:gdLst>
                    <a:gd name="T0" fmla="*/ 17 w 171"/>
                    <a:gd name="T1" fmla="*/ 1223 h 1223"/>
                    <a:gd name="T2" fmla="*/ 17 w 171"/>
                    <a:gd name="T3" fmla="*/ 0 h 1223"/>
                    <a:gd name="T4" fmla="*/ 0 w 171"/>
                    <a:gd name="T5" fmla="*/ 0 h 1223"/>
                    <a:gd name="T6" fmla="*/ 171 w 171"/>
                    <a:gd name="T7" fmla="*/ 0 h 1223"/>
                    <a:gd name="T8" fmla="*/ 153 w 171"/>
                    <a:gd name="T9" fmla="*/ 0 h 1223"/>
                    <a:gd name="T10" fmla="*/ 153 w 171"/>
                    <a:gd name="T11" fmla="*/ 1223 h 12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1" h="1223">
                      <a:moveTo>
                        <a:pt x="17" y="1223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1" y="0"/>
                      </a:lnTo>
                      <a:lnTo>
                        <a:pt x="153" y="0"/>
                      </a:lnTo>
                      <a:lnTo>
                        <a:pt x="153" y="1223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6" name="Rectangle 11"/>
                <p:cNvSpPr>
                  <a:spLocks noChangeArrowheads="1"/>
                </p:cNvSpPr>
                <p:nvPr/>
              </p:nvSpPr>
              <p:spPr bwMode="auto">
                <a:xfrm>
                  <a:off x="2028825" y="5959476"/>
                  <a:ext cx="107950" cy="995363"/>
                </a:xfrm>
                <a:prstGeom prst="rect">
                  <a:avLst/>
                </a:prstGeom>
                <a:solidFill>
                  <a:srgbClr val="A0A0A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7" name="Freeform 12"/>
                <p:cNvSpPr>
                  <a:spLocks/>
                </p:cNvSpPr>
                <p:nvPr/>
              </p:nvSpPr>
              <p:spPr bwMode="auto">
                <a:xfrm>
                  <a:off x="2014538" y="5959476"/>
                  <a:ext cx="136525" cy="995363"/>
                </a:xfrm>
                <a:custGeom>
                  <a:avLst/>
                  <a:gdLst>
                    <a:gd name="T0" fmla="*/ 18 w 171"/>
                    <a:gd name="T1" fmla="*/ 1254 h 1254"/>
                    <a:gd name="T2" fmla="*/ 18 w 171"/>
                    <a:gd name="T3" fmla="*/ 0 h 1254"/>
                    <a:gd name="T4" fmla="*/ 0 w 171"/>
                    <a:gd name="T5" fmla="*/ 0 h 1254"/>
                    <a:gd name="T6" fmla="*/ 171 w 171"/>
                    <a:gd name="T7" fmla="*/ 0 h 1254"/>
                    <a:gd name="T8" fmla="*/ 154 w 171"/>
                    <a:gd name="T9" fmla="*/ 0 h 1254"/>
                    <a:gd name="T10" fmla="*/ 154 w 171"/>
                    <a:gd name="T11" fmla="*/ 1254 h 12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1" h="1254">
                      <a:moveTo>
                        <a:pt x="18" y="1254"/>
                      </a:moveTo>
                      <a:lnTo>
                        <a:pt x="18" y="0"/>
                      </a:lnTo>
                      <a:lnTo>
                        <a:pt x="0" y="0"/>
                      </a:lnTo>
                      <a:lnTo>
                        <a:pt x="171" y="0"/>
                      </a:lnTo>
                      <a:lnTo>
                        <a:pt x="154" y="0"/>
                      </a:lnTo>
                      <a:lnTo>
                        <a:pt x="154" y="1254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8" name="Rectangle 13"/>
                <p:cNvSpPr>
                  <a:spLocks noChangeArrowheads="1"/>
                </p:cNvSpPr>
                <p:nvPr/>
              </p:nvSpPr>
              <p:spPr bwMode="auto">
                <a:xfrm>
                  <a:off x="2436813" y="5932488"/>
                  <a:ext cx="107950" cy="1022350"/>
                </a:xfrm>
                <a:prstGeom prst="rect">
                  <a:avLst/>
                </a:prstGeom>
                <a:solidFill>
                  <a:srgbClr val="A0A0A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9" name="Freeform 14"/>
                <p:cNvSpPr>
                  <a:spLocks/>
                </p:cNvSpPr>
                <p:nvPr/>
              </p:nvSpPr>
              <p:spPr bwMode="auto">
                <a:xfrm>
                  <a:off x="2422525" y="5932488"/>
                  <a:ext cx="136525" cy="1022350"/>
                </a:xfrm>
                <a:custGeom>
                  <a:avLst/>
                  <a:gdLst>
                    <a:gd name="T0" fmla="*/ 17 w 171"/>
                    <a:gd name="T1" fmla="*/ 1289 h 1289"/>
                    <a:gd name="T2" fmla="*/ 17 w 171"/>
                    <a:gd name="T3" fmla="*/ 0 h 1289"/>
                    <a:gd name="T4" fmla="*/ 0 w 171"/>
                    <a:gd name="T5" fmla="*/ 0 h 1289"/>
                    <a:gd name="T6" fmla="*/ 171 w 171"/>
                    <a:gd name="T7" fmla="*/ 0 h 1289"/>
                    <a:gd name="T8" fmla="*/ 154 w 171"/>
                    <a:gd name="T9" fmla="*/ 0 h 1289"/>
                    <a:gd name="T10" fmla="*/ 154 w 171"/>
                    <a:gd name="T11" fmla="*/ 1289 h 128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1" h="1289">
                      <a:moveTo>
                        <a:pt x="17" y="1289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1" y="0"/>
                      </a:lnTo>
                      <a:lnTo>
                        <a:pt x="154" y="0"/>
                      </a:lnTo>
                      <a:lnTo>
                        <a:pt x="154" y="1289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0" name="Rectangle 15"/>
                <p:cNvSpPr>
                  <a:spLocks noChangeArrowheads="1"/>
                </p:cNvSpPr>
                <p:nvPr/>
              </p:nvSpPr>
              <p:spPr bwMode="auto">
                <a:xfrm>
                  <a:off x="635000" y="5873751"/>
                  <a:ext cx="109538" cy="10810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1" name="Freeform 16"/>
                <p:cNvSpPr>
                  <a:spLocks/>
                </p:cNvSpPr>
                <p:nvPr/>
              </p:nvSpPr>
              <p:spPr bwMode="auto">
                <a:xfrm>
                  <a:off x="622300" y="5873751"/>
                  <a:ext cx="134938" cy="1081088"/>
                </a:xfrm>
                <a:custGeom>
                  <a:avLst/>
                  <a:gdLst>
                    <a:gd name="T0" fmla="*/ 18 w 171"/>
                    <a:gd name="T1" fmla="*/ 1362 h 1362"/>
                    <a:gd name="T2" fmla="*/ 18 w 171"/>
                    <a:gd name="T3" fmla="*/ 0 h 1362"/>
                    <a:gd name="T4" fmla="*/ 0 w 171"/>
                    <a:gd name="T5" fmla="*/ 0 h 1362"/>
                    <a:gd name="T6" fmla="*/ 171 w 171"/>
                    <a:gd name="T7" fmla="*/ 0 h 1362"/>
                    <a:gd name="T8" fmla="*/ 154 w 171"/>
                    <a:gd name="T9" fmla="*/ 0 h 1362"/>
                    <a:gd name="T10" fmla="*/ 154 w 171"/>
                    <a:gd name="T11" fmla="*/ 1362 h 13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1" h="1362">
                      <a:moveTo>
                        <a:pt x="18" y="1362"/>
                      </a:moveTo>
                      <a:lnTo>
                        <a:pt x="18" y="0"/>
                      </a:lnTo>
                      <a:lnTo>
                        <a:pt x="0" y="0"/>
                      </a:lnTo>
                      <a:lnTo>
                        <a:pt x="171" y="0"/>
                      </a:lnTo>
                      <a:lnTo>
                        <a:pt x="154" y="0"/>
                      </a:lnTo>
                      <a:lnTo>
                        <a:pt x="154" y="1362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2" name="Rectangle 17"/>
                <p:cNvSpPr>
                  <a:spLocks noChangeArrowheads="1"/>
                </p:cNvSpPr>
                <p:nvPr/>
              </p:nvSpPr>
              <p:spPr bwMode="auto">
                <a:xfrm>
                  <a:off x="1042988" y="5881688"/>
                  <a:ext cx="107950" cy="10731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3" name="Freeform 18"/>
                <p:cNvSpPr>
                  <a:spLocks/>
                </p:cNvSpPr>
                <p:nvPr/>
              </p:nvSpPr>
              <p:spPr bwMode="auto">
                <a:xfrm>
                  <a:off x="1028700" y="5881688"/>
                  <a:ext cx="134938" cy="1073150"/>
                </a:xfrm>
                <a:custGeom>
                  <a:avLst/>
                  <a:gdLst>
                    <a:gd name="T0" fmla="*/ 17 w 171"/>
                    <a:gd name="T1" fmla="*/ 1352 h 1352"/>
                    <a:gd name="T2" fmla="*/ 17 w 171"/>
                    <a:gd name="T3" fmla="*/ 0 h 1352"/>
                    <a:gd name="T4" fmla="*/ 0 w 171"/>
                    <a:gd name="T5" fmla="*/ 0 h 1352"/>
                    <a:gd name="T6" fmla="*/ 171 w 171"/>
                    <a:gd name="T7" fmla="*/ 0 h 1352"/>
                    <a:gd name="T8" fmla="*/ 154 w 171"/>
                    <a:gd name="T9" fmla="*/ 0 h 1352"/>
                    <a:gd name="T10" fmla="*/ 154 w 171"/>
                    <a:gd name="T11" fmla="*/ 1352 h 135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1" h="1352">
                      <a:moveTo>
                        <a:pt x="17" y="1352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1" y="0"/>
                      </a:lnTo>
                      <a:lnTo>
                        <a:pt x="154" y="0"/>
                      </a:lnTo>
                      <a:lnTo>
                        <a:pt x="154" y="1352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4" name="Rectangle 19"/>
                <p:cNvSpPr>
                  <a:spLocks noChangeArrowheads="1"/>
                </p:cNvSpPr>
                <p:nvPr/>
              </p:nvSpPr>
              <p:spPr bwMode="auto">
                <a:xfrm>
                  <a:off x="1450975" y="5991226"/>
                  <a:ext cx="107950" cy="9636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5" name="Freeform 20"/>
                <p:cNvSpPr>
                  <a:spLocks/>
                </p:cNvSpPr>
                <p:nvPr/>
              </p:nvSpPr>
              <p:spPr bwMode="auto">
                <a:xfrm>
                  <a:off x="1436688" y="5991226"/>
                  <a:ext cx="136525" cy="963613"/>
                </a:xfrm>
                <a:custGeom>
                  <a:avLst/>
                  <a:gdLst>
                    <a:gd name="T0" fmla="*/ 17 w 171"/>
                    <a:gd name="T1" fmla="*/ 1214 h 1214"/>
                    <a:gd name="T2" fmla="*/ 17 w 171"/>
                    <a:gd name="T3" fmla="*/ 0 h 1214"/>
                    <a:gd name="T4" fmla="*/ 0 w 171"/>
                    <a:gd name="T5" fmla="*/ 0 h 1214"/>
                    <a:gd name="T6" fmla="*/ 171 w 171"/>
                    <a:gd name="T7" fmla="*/ 0 h 1214"/>
                    <a:gd name="T8" fmla="*/ 153 w 171"/>
                    <a:gd name="T9" fmla="*/ 0 h 1214"/>
                    <a:gd name="T10" fmla="*/ 153 w 171"/>
                    <a:gd name="T11" fmla="*/ 1214 h 12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1" h="1214">
                      <a:moveTo>
                        <a:pt x="17" y="1214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1" y="0"/>
                      </a:lnTo>
                      <a:lnTo>
                        <a:pt x="153" y="0"/>
                      </a:lnTo>
                      <a:lnTo>
                        <a:pt x="153" y="1214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6" name="Rectangle 21"/>
                <p:cNvSpPr>
                  <a:spLocks noChangeArrowheads="1"/>
                </p:cNvSpPr>
                <p:nvPr/>
              </p:nvSpPr>
              <p:spPr bwMode="auto">
                <a:xfrm>
                  <a:off x="1858963" y="5975351"/>
                  <a:ext cx="107950" cy="9794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7" name="Freeform 22"/>
                <p:cNvSpPr>
                  <a:spLocks/>
                </p:cNvSpPr>
                <p:nvPr/>
              </p:nvSpPr>
              <p:spPr bwMode="auto">
                <a:xfrm>
                  <a:off x="1846263" y="5975351"/>
                  <a:ext cx="134938" cy="979488"/>
                </a:xfrm>
                <a:custGeom>
                  <a:avLst/>
                  <a:gdLst>
                    <a:gd name="T0" fmla="*/ 18 w 171"/>
                    <a:gd name="T1" fmla="*/ 1233 h 1233"/>
                    <a:gd name="T2" fmla="*/ 18 w 171"/>
                    <a:gd name="T3" fmla="*/ 0 h 1233"/>
                    <a:gd name="T4" fmla="*/ 0 w 171"/>
                    <a:gd name="T5" fmla="*/ 0 h 1233"/>
                    <a:gd name="T6" fmla="*/ 171 w 171"/>
                    <a:gd name="T7" fmla="*/ 0 h 1233"/>
                    <a:gd name="T8" fmla="*/ 154 w 171"/>
                    <a:gd name="T9" fmla="*/ 0 h 1233"/>
                    <a:gd name="T10" fmla="*/ 154 w 171"/>
                    <a:gd name="T11" fmla="*/ 1233 h 12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1" h="1233">
                      <a:moveTo>
                        <a:pt x="18" y="1233"/>
                      </a:moveTo>
                      <a:lnTo>
                        <a:pt x="18" y="0"/>
                      </a:lnTo>
                      <a:lnTo>
                        <a:pt x="0" y="0"/>
                      </a:lnTo>
                      <a:lnTo>
                        <a:pt x="171" y="0"/>
                      </a:lnTo>
                      <a:lnTo>
                        <a:pt x="154" y="0"/>
                      </a:lnTo>
                      <a:lnTo>
                        <a:pt x="154" y="1233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8" name="Rectangle 23"/>
                <p:cNvSpPr>
                  <a:spLocks noChangeArrowheads="1"/>
                </p:cNvSpPr>
                <p:nvPr/>
              </p:nvSpPr>
              <p:spPr bwMode="auto">
                <a:xfrm>
                  <a:off x="2266950" y="5927726"/>
                  <a:ext cx="107950" cy="10271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9" name="Freeform 24"/>
                <p:cNvSpPr>
                  <a:spLocks/>
                </p:cNvSpPr>
                <p:nvPr/>
              </p:nvSpPr>
              <p:spPr bwMode="auto">
                <a:xfrm>
                  <a:off x="2252663" y="5927726"/>
                  <a:ext cx="134938" cy="1027113"/>
                </a:xfrm>
                <a:custGeom>
                  <a:avLst/>
                  <a:gdLst>
                    <a:gd name="T0" fmla="*/ 17 w 171"/>
                    <a:gd name="T1" fmla="*/ 1295 h 1295"/>
                    <a:gd name="T2" fmla="*/ 17 w 171"/>
                    <a:gd name="T3" fmla="*/ 0 h 1295"/>
                    <a:gd name="T4" fmla="*/ 0 w 171"/>
                    <a:gd name="T5" fmla="*/ 0 h 1295"/>
                    <a:gd name="T6" fmla="*/ 171 w 171"/>
                    <a:gd name="T7" fmla="*/ 0 h 1295"/>
                    <a:gd name="T8" fmla="*/ 154 w 171"/>
                    <a:gd name="T9" fmla="*/ 0 h 1295"/>
                    <a:gd name="T10" fmla="*/ 154 w 171"/>
                    <a:gd name="T11" fmla="*/ 1295 h 12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1" h="1295">
                      <a:moveTo>
                        <a:pt x="17" y="1295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1" y="0"/>
                      </a:lnTo>
                      <a:lnTo>
                        <a:pt x="154" y="0"/>
                      </a:lnTo>
                      <a:lnTo>
                        <a:pt x="154" y="1295"/>
                      </a:lnTo>
                    </a:path>
                  </a:pathLst>
                </a:custGeom>
                <a:noFill/>
                <a:ln w="269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0" name="Rectangle 25"/>
                <p:cNvSpPr>
                  <a:spLocks noChangeArrowheads="1"/>
                </p:cNvSpPr>
                <p:nvPr/>
              </p:nvSpPr>
              <p:spPr bwMode="auto">
                <a:xfrm>
                  <a:off x="738188" y="7051676"/>
                  <a:ext cx="12700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3" name="Rectangle 26"/>
                <p:cNvSpPr>
                  <a:spLocks noChangeArrowheads="1"/>
                </p:cNvSpPr>
                <p:nvPr/>
              </p:nvSpPr>
              <p:spPr bwMode="auto">
                <a:xfrm>
                  <a:off x="1146175" y="7051676"/>
                  <a:ext cx="12700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6" name="Rectangle 27"/>
                <p:cNvSpPr>
                  <a:spLocks noChangeArrowheads="1"/>
                </p:cNvSpPr>
                <p:nvPr/>
              </p:nvSpPr>
              <p:spPr bwMode="auto">
                <a:xfrm>
                  <a:off x="1552575" y="7051676"/>
                  <a:ext cx="12700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1" name="Rectangle 28"/>
                <p:cNvSpPr>
                  <a:spLocks noChangeArrowheads="1"/>
                </p:cNvSpPr>
                <p:nvPr/>
              </p:nvSpPr>
              <p:spPr bwMode="auto">
                <a:xfrm>
                  <a:off x="1962150" y="7051676"/>
                  <a:ext cx="12700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" name="Rectangle 29"/>
                <p:cNvSpPr>
                  <a:spLocks noChangeArrowheads="1"/>
                </p:cNvSpPr>
                <p:nvPr/>
              </p:nvSpPr>
              <p:spPr bwMode="auto">
                <a:xfrm>
                  <a:off x="2370138" y="7051676"/>
                  <a:ext cx="12700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6" name="Line 30"/>
                <p:cNvSpPr>
                  <a:spLocks noChangeShapeType="1"/>
                </p:cNvSpPr>
                <p:nvPr/>
              </p:nvSpPr>
              <p:spPr bwMode="auto">
                <a:xfrm>
                  <a:off x="544513" y="6954838"/>
                  <a:ext cx="2093913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7" name="Line 31"/>
                <p:cNvSpPr>
                  <a:spLocks noChangeShapeType="1"/>
                </p:cNvSpPr>
                <p:nvPr/>
              </p:nvSpPr>
              <p:spPr bwMode="auto">
                <a:xfrm flipV="1">
                  <a:off x="773113" y="6954838"/>
                  <a:ext cx="0" cy="777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8" name="Line 32"/>
                <p:cNvSpPr>
                  <a:spLocks noChangeShapeType="1"/>
                </p:cNvSpPr>
                <p:nvPr/>
              </p:nvSpPr>
              <p:spPr bwMode="auto">
                <a:xfrm flipV="1">
                  <a:off x="1181100" y="6954838"/>
                  <a:ext cx="0" cy="777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3" name="Line 33"/>
                <p:cNvSpPr>
                  <a:spLocks noChangeShapeType="1"/>
                </p:cNvSpPr>
                <p:nvPr/>
              </p:nvSpPr>
              <p:spPr bwMode="auto">
                <a:xfrm flipV="1">
                  <a:off x="1587500" y="6954838"/>
                  <a:ext cx="0" cy="777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4" name="Line 34"/>
                <p:cNvSpPr>
                  <a:spLocks noChangeShapeType="1"/>
                </p:cNvSpPr>
                <p:nvPr/>
              </p:nvSpPr>
              <p:spPr bwMode="auto">
                <a:xfrm flipV="1">
                  <a:off x="1997075" y="6954838"/>
                  <a:ext cx="0" cy="777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5" name="Line 35"/>
                <p:cNvSpPr>
                  <a:spLocks noChangeShapeType="1"/>
                </p:cNvSpPr>
                <p:nvPr/>
              </p:nvSpPr>
              <p:spPr bwMode="auto">
                <a:xfrm flipV="1">
                  <a:off x="2405063" y="6954838"/>
                  <a:ext cx="0" cy="777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6" name="Rectangle 36"/>
                <p:cNvSpPr>
                  <a:spLocks noChangeArrowheads="1"/>
                </p:cNvSpPr>
                <p:nvPr/>
              </p:nvSpPr>
              <p:spPr bwMode="auto">
                <a:xfrm>
                  <a:off x="387350" y="6884988"/>
                  <a:ext cx="12700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7" name="Rectangle 37"/>
                <p:cNvSpPr>
                  <a:spLocks noChangeArrowheads="1"/>
                </p:cNvSpPr>
                <p:nvPr/>
              </p:nvSpPr>
              <p:spPr bwMode="auto">
                <a:xfrm>
                  <a:off x="317500" y="6664326"/>
                  <a:ext cx="19685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8" name="Rectangle 38"/>
                <p:cNvSpPr>
                  <a:spLocks noChangeArrowheads="1"/>
                </p:cNvSpPr>
                <p:nvPr/>
              </p:nvSpPr>
              <p:spPr bwMode="auto">
                <a:xfrm>
                  <a:off x="317500" y="6442076"/>
                  <a:ext cx="19685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9" name="Rectangle 39"/>
                <p:cNvSpPr>
                  <a:spLocks noChangeArrowheads="1"/>
                </p:cNvSpPr>
                <p:nvPr/>
              </p:nvSpPr>
              <p:spPr bwMode="auto">
                <a:xfrm>
                  <a:off x="317500" y="6221413"/>
                  <a:ext cx="19685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0" name="Rectangle 40"/>
                <p:cNvSpPr>
                  <a:spLocks noChangeArrowheads="1"/>
                </p:cNvSpPr>
                <p:nvPr/>
              </p:nvSpPr>
              <p:spPr bwMode="auto">
                <a:xfrm>
                  <a:off x="317500" y="6000751"/>
                  <a:ext cx="19685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8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1" name="Rectangle 41"/>
                <p:cNvSpPr>
                  <a:spLocks noChangeArrowheads="1"/>
                </p:cNvSpPr>
                <p:nvPr/>
              </p:nvSpPr>
              <p:spPr bwMode="auto">
                <a:xfrm>
                  <a:off x="247650" y="5778501"/>
                  <a:ext cx="266700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2" name="Line 42"/>
                <p:cNvSpPr>
                  <a:spLocks noChangeShapeType="1"/>
                </p:cNvSpPr>
                <p:nvPr/>
              </p:nvSpPr>
              <p:spPr bwMode="auto">
                <a:xfrm flipV="1">
                  <a:off x="554038" y="5838826"/>
                  <a:ext cx="0" cy="112553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3" name="Line 43"/>
                <p:cNvSpPr>
                  <a:spLocks noChangeShapeType="1"/>
                </p:cNvSpPr>
                <p:nvPr/>
              </p:nvSpPr>
              <p:spPr bwMode="auto">
                <a:xfrm flipH="1">
                  <a:off x="476250" y="6954838"/>
                  <a:ext cx="7778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4" name="Line 44"/>
                <p:cNvSpPr>
                  <a:spLocks noChangeShapeType="1"/>
                </p:cNvSpPr>
                <p:nvPr/>
              </p:nvSpPr>
              <p:spPr bwMode="auto">
                <a:xfrm flipH="1">
                  <a:off x="476250" y="6734176"/>
                  <a:ext cx="7778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5" name="Line 45"/>
                <p:cNvSpPr>
                  <a:spLocks noChangeShapeType="1"/>
                </p:cNvSpPr>
                <p:nvPr/>
              </p:nvSpPr>
              <p:spPr bwMode="auto">
                <a:xfrm flipH="1">
                  <a:off x="476250" y="6513513"/>
                  <a:ext cx="7778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6" name="Line 46"/>
                <p:cNvSpPr>
                  <a:spLocks noChangeShapeType="1"/>
                </p:cNvSpPr>
                <p:nvPr/>
              </p:nvSpPr>
              <p:spPr bwMode="auto">
                <a:xfrm flipH="1">
                  <a:off x="476250" y="6291263"/>
                  <a:ext cx="7778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7" name="Line 47"/>
                <p:cNvSpPr>
                  <a:spLocks noChangeShapeType="1"/>
                </p:cNvSpPr>
                <p:nvPr/>
              </p:nvSpPr>
              <p:spPr bwMode="auto">
                <a:xfrm flipH="1">
                  <a:off x="476250" y="6070601"/>
                  <a:ext cx="7778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8" name="Line 48"/>
                <p:cNvSpPr>
                  <a:spLocks noChangeShapeType="1"/>
                </p:cNvSpPr>
                <p:nvPr/>
              </p:nvSpPr>
              <p:spPr bwMode="auto">
                <a:xfrm flipH="1">
                  <a:off x="476250" y="5848351"/>
                  <a:ext cx="7778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9" name="Rectangle 49"/>
                <p:cNvSpPr>
                  <a:spLocks noChangeArrowheads="1"/>
                </p:cNvSpPr>
                <p:nvPr/>
              </p:nvSpPr>
              <p:spPr bwMode="auto">
                <a:xfrm>
                  <a:off x="1320800" y="7279230"/>
                  <a:ext cx="582613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Recipient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0" name="Rectangle 50"/>
                <p:cNvSpPr>
                  <a:spLocks noChangeArrowheads="1"/>
                </p:cNvSpPr>
                <p:nvPr/>
              </p:nvSpPr>
              <p:spPr bwMode="auto">
                <a:xfrm>
                  <a:off x="1181100" y="5573520"/>
                  <a:ext cx="842963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Dendritic cells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167" name="Group 166"/>
              <p:cNvGrpSpPr/>
              <p:nvPr/>
            </p:nvGrpSpPr>
            <p:grpSpPr>
              <a:xfrm>
                <a:off x="5271191" y="6103397"/>
                <a:ext cx="1186652" cy="419361"/>
                <a:chOff x="5547524" y="6103397"/>
                <a:chExt cx="1186652" cy="419361"/>
              </a:xfrm>
            </p:grpSpPr>
            <p:sp>
              <p:nvSpPr>
                <p:cNvPr id="160" name="Rectangle 100"/>
                <p:cNvSpPr>
                  <a:spLocks noChangeArrowheads="1"/>
                </p:cNvSpPr>
                <p:nvPr/>
              </p:nvSpPr>
              <p:spPr bwMode="auto">
                <a:xfrm>
                  <a:off x="5827713" y="6103397"/>
                  <a:ext cx="611188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Untreated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1" name="Rectangle 101"/>
                <p:cNvSpPr>
                  <a:spLocks noChangeArrowheads="1"/>
                </p:cNvSpPr>
                <p:nvPr/>
              </p:nvSpPr>
              <p:spPr bwMode="auto">
                <a:xfrm>
                  <a:off x="5547680" y="6144538"/>
                  <a:ext cx="209594" cy="91839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" name="Rectangle 103"/>
                <p:cNvSpPr>
                  <a:spLocks noChangeArrowheads="1"/>
                </p:cNvSpPr>
                <p:nvPr/>
              </p:nvSpPr>
              <p:spPr bwMode="auto">
                <a:xfrm>
                  <a:off x="5827713" y="6354483"/>
                  <a:ext cx="906463" cy="1682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ells + e5 SEV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4" name="Rectangle 104"/>
                <p:cNvSpPr>
                  <a:spLocks noChangeArrowheads="1"/>
                </p:cNvSpPr>
                <p:nvPr/>
              </p:nvSpPr>
              <p:spPr bwMode="auto">
                <a:xfrm>
                  <a:off x="5547524" y="6398625"/>
                  <a:ext cx="206474" cy="93249"/>
                </a:xfrm>
                <a:prstGeom prst="rect">
                  <a:avLst/>
                </a:prstGeom>
                <a:solidFill>
                  <a:srgbClr val="A0A0A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170" name="TextBox 169"/>
              <p:cNvSpPr txBox="1"/>
              <p:nvPr/>
            </p:nvSpPr>
            <p:spPr>
              <a:xfrm rot="16200000">
                <a:off x="-434606" y="6278484"/>
                <a:ext cx="11842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ercent live DC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2" name="Group 171"/>
              <p:cNvGrpSpPr/>
              <p:nvPr/>
            </p:nvGrpSpPr>
            <p:grpSpPr>
              <a:xfrm>
                <a:off x="2759196" y="5585018"/>
                <a:ext cx="2411292" cy="1862748"/>
                <a:chOff x="2759196" y="5585018"/>
                <a:chExt cx="2411292" cy="1862748"/>
              </a:xfrm>
            </p:grpSpPr>
            <p:grpSp>
              <p:nvGrpSpPr>
                <p:cNvPr id="169" name="Group 168"/>
                <p:cNvGrpSpPr/>
                <p:nvPr/>
              </p:nvGrpSpPr>
              <p:grpSpPr>
                <a:xfrm>
                  <a:off x="2952750" y="5585018"/>
                  <a:ext cx="2217738" cy="1862748"/>
                  <a:chOff x="2952750" y="5585018"/>
                  <a:chExt cx="2217738" cy="1862748"/>
                </a:xfrm>
              </p:grpSpPr>
              <p:sp>
                <p:nvSpPr>
                  <p:cNvPr id="111" name="Rectangle 51"/>
                  <p:cNvSpPr>
                    <a:spLocks noChangeArrowheads="1"/>
                  </p:cNvSpPr>
                  <p:nvPr/>
                </p:nvSpPr>
                <p:spPr bwMode="auto">
                  <a:xfrm>
                    <a:off x="3492501" y="6061076"/>
                    <a:ext cx="95250" cy="893763"/>
                  </a:xfrm>
                  <a:prstGeom prst="rect">
                    <a:avLst/>
                  </a:prstGeom>
                  <a:solidFill>
                    <a:srgbClr val="A0A0A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12" name="Freeform 52"/>
                  <p:cNvSpPr>
                    <a:spLocks/>
                  </p:cNvSpPr>
                  <p:nvPr/>
                </p:nvSpPr>
                <p:spPr bwMode="auto">
                  <a:xfrm>
                    <a:off x="3478213" y="6061076"/>
                    <a:ext cx="123825" cy="893763"/>
                  </a:xfrm>
                  <a:custGeom>
                    <a:avLst/>
                    <a:gdLst>
                      <a:gd name="T0" fmla="*/ 17 w 155"/>
                      <a:gd name="T1" fmla="*/ 1125 h 1125"/>
                      <a:gd name="T2" fmla="*/ 17 w 155"/>
                      <a:gd name="T3" fmla="*/ 0 h 1125"/>
                      <a:gd name="T4" fmla="*/ 0 w 155"/>
                      <a:gd name="T5" fmla="*/ 0 h 1125"/>
                      <a:gd name="T6" fmla="*/ 155 w 155"/>
                      <a:gd name="T7" fmla="*/ 0 h 1125"/>
                      <a:gd name="T8" fmla="*/ 138 w 155"/>
                      <a:gd name="T9" fmla="*/ 0 h 1125"/>
                      <a:gd name="T10" fmla="*/ 138 w 155"/>
                      <a:gd name="T11" fmla="*/ 1125 h 112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5" h="1125">
                        <a:moveTo>
                          <a:pt x="17" y="1125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55" y="0"/>
                        </a:lnTo>
                        <a:lnTo>
                          <a:pt x="138" y="0"/>
                        </a:lnTo>
                        <a:lnTo>
                          <a:pt x="138" y="1125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13" name="Rectangle 53"/>
                  <p:cNvSpPr>
                    <a:spLocks noChangeArrowheads="1"/>
                  </p:cNvSpPr>
                  <p:nvPr/>
                </p:nvSpPr>
                <p:spPr bwMode="auto">
                  <a:xfrm>
                    <a:off x="3865563" y="6072188"/>
                    <a:ext cx="95250" cy="882650"/>
                  </a:xfrm>
                  <a:prstGeom prst="rect">
                    <a:avLst/>
                  </a:prstGeom>
                  <a:solidFill>
                    <a:srgbClr val="A0A0A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14" name="Freeform 54"/>
                  <p:cNvSpPr>
                    <a:spLocks/>
                  </p:cNvSpPr>
                  <p:nvPr/>
                </p:nvSpPr>
                <p:spPr bwMode="auto">
                  <a:xfrm>
                    <a:off x="3851276" y="6072188"/>
                    <a:ext cx="123825" cy="882650"/>
                  </a:xfrm>
                  <a:custGeom>
                    <a:avLst/>
                    <a:gdLst>
                      <a:gd name="T0" fmla="*/ 17 w 156"/>
                      <a:gd name="T1" fmla="*/ 1112 h 1112"/>
                      <a:gd name="T2" fmla="*/ 17 w 156"/>
                      <a:gd name="T3" fmla="*/ 0 h 1112"/>
                      <a:gd name="T4" fmla="*/ 0 w 156"/>
                      <a:gd name="T5" fmla="*/ 0 h 1112"/>
                      <a:gd name="T6" fmla="*/ 156 w 156"/>
                      <a:gd name="T7" fmla="*/ 0 h 1112"/>
                      <a:gd name="T8" fmla="*/ 138 w 156"/>
                      <a:gd name="T9" fmla="*/ 0 h 1112"/>
                      <a:gd name="T10" fmla="*/ 138 w 156"/>
                      <a:gd name="T11" fmla="*/ 1112 h 111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6" h="1112">
                        <a:moveTo>
                          <a:pt x="17" y="1112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56" y="0"/>
                        </a:lnTo>
                        <a:lnTo>
                          <a:pt x="138" y="0"/>
                        </a:lnTo>
                        <a:lnTo>
                          <a:pt x="138" y="1112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15" name="Rectangle 55"/>
                  <p:cNvSpPr>
                    <a:spLocks noChangeArrowheads="1"/>
                  </p:cNvSpPr>
                  <p:nvPr/>
                </p:nvSpPr>
                <p:spPr bwMode="auto">
                  <a:xfrm>
                    <a:off x="4238626" y="6051551"/>
                    <a:ext cx="95250" cy="903288"/>
                  </a:xfrm>
                  <a:prstGeom prst="rect">
                    <a:avLst/>
                  </a:prstGeom>
                  <a:solidFill>
                    <a:srgbClr val="A0A0A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16" name="Freeform 56"/>
                  <p:cNvSpPr>
                    <a:spLocks/>
                  </p:cNvSpPr>
                  <p:nvPr/>
                </p:nvSpPr>
                <p:spPr bwMode="auto">
                  <a:xfrm>
                    <a:off x="4224338" y="6051551"/>
                    <a:ext cx="123825" cy="903288"/>
                  </a:xfrm>
                  <a:custGeom>
                    <a:avLst/>
                    <a:gdLst>
                      <a:gd name="T0" fmla="*/ 17 w 155"/>
                      <a:gd name="T1" fmla="*/ 1137 h 1137"/>
                      <a:gd name="T2" fmla="*/ 17 w 155"/>
                      <a:gd name="T3" fmla="*/ 0 h 1137"/>
                      <a:gd name="T4" fmla="*/ 0 w 155"/>
                      <a:gd name="T5" fmla="*/ 0 h 1137"/>
                      <a:gd name="T6" fmla="*/ 155 w 155"/>
                      <a:gd name="T7" fmla="*/ 0 h 1137"/>
                      <a:gd name="T8" fmla="*/ 138 w 155"/>
                      <a:gd name="T9" fmla="*/ 0 h 1137"/>
                      <a:gd name="T10" fmla="*/ 138 w 155"/>
                      <a:gd name="T11" fmla="*/ 1137 h 113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5" h="1137">
                        <a:moveTo>
                          <a:pt x="17" y="1137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55" y="0"/>
                        </a:lnTo>
                        <a:lnTo>
                          <a:pt x="138" y="0"/>
                        </a:lnTo>
                        <a:lnTo>
                          <a:pt x="138" y="1137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17" name="Rectangle 57"/>
                  <p:cNvSpPr>
                    <a:spLocks noChangeArrowheads="1"/>
                  </p:cNvSpPr>
                  <p:nvPr/>
                </p:nvSpPr>
                <p:spPr bwMode="auto">
                  <a:xfrm>
                    <a:off x="4611688" y="6002338"/>
                    <a:ext cx="96838" cy="952500"/>
                  </a:xfrm>
                  <a:prstGeom prst="rect">
                    <a:avLst/>
                  </a:prstGeom>
                  <a:solidFill>
                    <a:srgbClr val="A0A0A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18" name="Freeform 58"/>
                  <p:cNvSpPr>
                    <a:spLocks/>
                  </p:cNvSpPr>
                  <p:nvPr/>
                </p:nvSpPr>
                <p:spPr bwMode="auto">
                  <a:xfrm>
                    <a:off x="4598988" y="6002338"/>
                    <a:ext cx="122238" cy="952500"/>
                  </a:xfrm>
                  <a:custGeom>
                    <a:avLst/>
                    <a:gdLst>
                      <a:gd name="T0" fmla="*/ 17 w 156"/>
                      <a:gd name="T1" fmla="*/ 1200 h 1200"/>
                      <a:gd name="T2" fmla="*/ 17 w 156"/>
                      <a:gd name="T3" fmla="*/ 0 h 1200"/>
                      <a:gd name="T4" fmla="*/ 0 w 156"/>
                      <a:gd name="T5" fmla="*/ 0 h 1200"/>
                      <a:gd name="T6" fmla="*/ 156 w 156"/>
                      <a:gd name="T7" fmla="*/ 0 h 1200"/>
                      <a:gd name="T8" fmla="*/ 138 w 156"/>
                      <a:gd name="T9" fmla="*/ 0 h 1200"/>
                      <a:gd name="T10" fmla="*/ 138 w 156"/>
                      <a:gd name="T11" fmla="*/ 1200 h 120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6" h="1200">
                        <a:moveTo>
                          <a:pt x="17" y="120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56" y="0"/>
                        </a:lnTo>
                        <a:lnTo>
                          <a:pt x="138" y="0"/>
                        </a:lnTo>
                        <a:lnTo>
                          <a:pt x="138" y="1200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19" name="Rectangle 59"/>
                  <p:cNvSpPr>
                    <a:spLocks noChangeArrowheads="1"/>
                  </p:cNvSpPr>
                  <p:nvPr/>
                </p:nvSpPr>
                <p:spPr bwMode="auto">
                  <a:xfrm>
                    <a:off x="4984751" y="5978526"/>
                    <a:ext cx="96838" cy="976313"/>
                  </a:xfrm>
                  <a:prstGeom prst="rect">
                    <a:avLst/>
                  </a:prstGeom>
                  <a:solidFill>
                    <a:srgbClr val="A0A0A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0" name="Freeform 60"/>
                  <p:cNvSpPr>
                    <a:spLocks/>
                  </p:cNvSpPr>
                  <p:nvPr/>
                </p:nvSpPr>
                <p:spPr bwMode="auto">
                  <a:xfrm>
                    <a:off x="4972051" y="5978526"/>
                    <a:ext cx="122238" cy="976313"/>
                  </a:xfrm>
                  <a:custGeom>
                    <a:avLst/>
                    <a:gdLst>
                      <a:gd name="T0" fmla="*/ 18 w 156"/>
                      <a:gd name="T1" fmla="*/ 1229 h 1229"/>
                      <a:gd name="T2" fmla="*/ 18 w 156"/>
                      <a:gd name="T3" fmla="*/ 0 h 1229"/>
                      <a:gd name="T4" fmla="*/ 0 w 156"/>
                      <a:gd name="T5" fmla="*/ 0 h 1229"/>
                      <a:gd name="T6" fmla="*/ 156 w 156"/>
                      <a:gd name="T7" fmla="*/ 0 h 1229"/>
                      <a:gd name="T8" fmla="*/ 139 w 156"/>
                      <a:gd name="T9" fmla="*/ 0 h 1229"/>
                      <a:gd name="T10" fmla="*/ 139 w 156"/>
                      <a:gd name="T11" fmla="*/ 1229 h 122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6" h="1229">
                        <a:moveTo>
                          <a:pt x="18" y="1229"/>
                        </a:moveTo>
                        <a:lnTo>
                          <a:pt x="18" y="0"/>
                        </a:lnTo>
                        <a:lnTo>
                          <a:pt x="0" y="0"/>
                        </a:lnTo>
                        <a:lnTo>
                          <a:pt x="156" y="0"/>
                        </a:lnTo>
                        <a:lnTo>
                          <a:pt x="139" y="0"/>
                        </a:lnTo>
                        <a:lnTo>
                          <a:pt x="139" y="1229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1" name="Rectangle 61"/>
                  <p:cNvSpPr>
                    <a:spLocks noChangeArrowheads="1"/>
                  </p:cNvSpPr>
                  <p:nvPr/>
                </p:nvSpPr>
                <p:spPr bwMode="auto">
                  <a:xfrm>
                    <a:off x="3335338" y="5902326"/>
                    <a:ext cx="95250" cy="1052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2" name="Freeform 62"/>
                  <p:cNvSpPr>
                    <a:spLocks/>
                  </p:cNvSpPr>
                  <p:nvPr/>
                </p:nvSpPr>
                <p:spPr bwMode="auto">
                  <a:xfrm>
                    <a:off x="3321050" y="5902326"/>
                    <a:ext cx="123825" cy="1052513"/>
                  </a:xfrm>
                  <a:custGeom>
                    <a:avLst/>
                    <a:gdLst>
                      <a:gd name="T0" fmla="*/ 17 w 155"/>
                      <a:gd name="T1" fmla="*/ 1325 h 1325"/>
                      <a:gd name="T2" fmla="*/ 17 w 155"/>
                      <a:gd name="T3" fmla="*/ 0 h 1325"/>
                      <a:gd name="T4" fmla="*/ 0 w 155"/>
                      <a:gd name="T5" fmla="*/ 0 h 1325"/>
                      <a:gd name="T6" fmla="*/ 155 w 155"/>
                      <a:gd name="T7" fmla="*/ 0 h 1325"/>
                      <a:gd name="T8" fmla="*/ 138 w 155"/>
                      <a:gd name="T9" fmla="*/ 0 h 1325"/>
                      <a:gd name="T10" fmla="*/ 138 w 155"/>
                      <a:gd name="T11" fmla="*/ 1325 h 132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5" h="1325">
                        <a:moveTo>
                          <a:pt x="17" y="1325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55" y="0"/>
                        </a:lnTo>
                        <a:lnTo>
                          <a:pt x="138" y="0"/>
                        </a:lnTo>
                        <a:lnTo>
                          <a:pt x="138" y="1325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3" name="Rectangle 63"/>
                  <p:cNvSpPr>
                    <a:spLocks noChangeArrowheads="1"/>
                  </p:cNvSpPr>
                  <p:nvPr/>
                </p:nvSpPr>
                <p:spPr bwMode="auto">
                  <a:xfrm>
                    <a:off x="3708401" y="6045201"/>
                    <a:ext cx="95250" cy="9096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4" name="Freeform 64"/>
                  <p:cNvSpPr>
                    <a:spLocks/>
                  </p:cNvSpPr>
                  <p:nvPr/>
                </p:nvSpPr>
                <p:spPr bwMode="auto">
                  <a:xfrm>
                    <a:off x="3694113" y="6045201"/>
                    <a:ext cx="123825" cy="909638"/>
                  </a:xfrm>
                  <a:custGeom>
                    <a:avLst/>
                    <a:gdLst>
                      <a:gd name="T0" fmla="*/ 18 w 156"/>
                      <a:gd name="T1" fmla="*/ 1147 h 1147"/>
                      <a:gd name="T2" fmla="*/ 18 w 156"/>
                      <a:gd name="T3" fmla="*/ 0 h 1147"/>
                      <a:gd name="T4" fmla="*/ 0 w 156"/>
                      <a:gd name="T5" fmla="*/ 0 h 1147"/>
                      <a:gd name="T6" fmla="*/ 156 w 156"/>
                      <a:gd name="T7" fmla="*/ 0 h 1147"/>
                      <a:gd name="T8" fmla="*/ 139 w 156"/>
                      <a:gd name="T9" fmla="*/ 0 h 1147"/>
                      <a:gd name="T10" fmla="*/ 139 w 156"/>
                      <a:gd name="T11" fmla="*/ 1147 h 114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6" h="1147">
                        <a:moveTo>
                          <a:pt x="18" y="1147"/>
                        </a:moveTo>
                        <a:lnTo>
                          <a:pt x="18" y="0"/>
                        </a:lnTo>
                        <a:lnTo>
                          <a:pt x="0" y="0"/>
                        </a:lnTo>
                        <a:lnTo>
                          <a:pt x="156" y="0"/>
                        </a:lnTo>
                        <a:lnTo>
                          <a:pt x="139" y="0"/>
                        </a:lnTo>
                        <a:lnTo>
                          <a:pt x="139" y="1147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5" name="Rectangle 65"/>
                  <p:cNvSpPr>
                    <a:spLocks noChangeArrowheads="1"/>
                  </p:cNvSpPr>
                  <p:nvPr/>
                </p:nvSpPr>
                <p:spPr bwMode="auto">
                  <a:xfrm>
                    <a:off x="4081463" y="6038851"/>
                    <a:ext cx="96838" cy="91598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6" name="Freeform 66"/>
                  <p:cNvSpPr>
                    <a:spLocks/>
                  </p:cNvSpPr>
                  <p:nvPr/>
                </p:nvSpPr>
                <p:spPr bwMode="auto">
                  <a:xfrm>
                    <a:off x="4067176" y="6038851"/>
                    <a:ext cx="123825" cy="915988"/>
                  </a:xfrm>
                  <a:custGeom>
                    <a:avLst/>
                    <a:gdLst>
                      <a:gd name="T0" fmla="*/ 17 w 155"/>
                      <a:gd name="T1" fmla="*/ 1154 h 1154"/>
                      <a:gd name="T2" fmla="*/ 17 w 155"/>
                      <a:gd name="T3" fmla="*/ 0 h 1154"/>
                      <a:gd name="T4" fmla="*/ 0 w 155"/>
                      <a:gd name="T5" fmla="*/ 0 h 1154"/>
                      <a:gd name="T6" fmla="*/ 155 w 155"/>
                      <a:gd name="T7" fmla="*/ 0 h 1154"/>
                      <a:gd name="T8" fmla="*/ 138 w 155"/>
                      <a:gd name="T9" fmla="*/ 0 h 1154"/>
                      <a:gd name="T10" fmla="*/ 138 w 155"/>
                      <a:gd name="T11" fmla="*/ 1154 h 115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5" h="1154">
                        <a:moveTo>
                          <a:pt x="17" y="1154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55" y="0"/>
                        </a:lnTo>
                        <a:lnTo>
                          <a:pt x="138" y="0"/>
                        </a:lnTo>
                        <a:lnTo>
                          <a:pt x="138" y="1154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7" name="Rectangle 67"/>
                  <p:cNvSpPr>
                    <a:spLocks noChangeArrowheads="1"/>
                  </p:cNvSpPr>
                  <p:nvPr/>
                </p:nvSpPr>
                <p:spPr bwMode="auto">
                  <a:xfrm>
                    <a:off x="4454526" y="5994401"/>
                    <a:ext cx="96838" cy="9604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8" name="Freeform 68"/>
                  <p:cNvSpPr>
                    <a:spLocks/>
                  </p:cNvSpPr>
                  <p:nvPr/>
                </p:nvSpPr>
                <p:spPr bwMode="auto">
                  <a:xfrm>
                    <a:off x="4441826" y="5994401"/>
                    <a:ext cx="122238" cy="960438"/>
                  </a:xfrm>
                  <a:custGeom>
                    <a:avLst/>
                    <a:gdLst>
                      <a:gd name="T0" fmla="*/ 18 w 156"/>
                      <a:gd name="T1" fmla="*/ 1210 h 1210"/>
                      <a:gd name="T2" fmla="*/ 18 w 156"/>
                      <a:gd name="T3" fmla="*/ 0 h 1210"/>
                      <a:gd name="T4" fmla="*/ 0 w 156"/>
                      <a:gd name="T5" fmla="*/ 0 h 1210"/>
                      <a:gd name="T6" fmla="*/ 156 w 156"/>
                      <a:gd name="T7" fmla="*/ 0 h 1210"/>
                      <a:gd name="T8" fmla="*/ 138 w 156"/>
                      <a:gd name="T9" fmla="*/ 0 h 1210"/>
                      <a:gd name="T10" fmla="*/ 138 w 156"/>
                      <a:gd name="T11" fmla="*/ 1210 h 12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6" h="1210">
                        <a:moveTo>
                          <a:pt x="18" y="1210"/>
                        </a:moveTo>
                        <a:lnTo>
                          <a:pt x="18" y="0"/>
                        </a:lnTo>
                        <a:lnTo>
                          <a:pt x="0" y="0"/>
                        </a:lnTo>
                        <a:lnTo>
                          <a:pt x="156" y="0"/>
                        </a:lnTo>
                        <a:lnTo>
                          <a:pt x="138" y="0"/>
                        </a:lnTo>
                        <a:lnTo>
                          <a:pt x="138" y="1210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29" name="Rectangle 69"/>
                  <p:cNvSpPr>
                    <a:spLocks noChangeArrowheads="1"/>
                  </p:cNvSpPr>
                  <p:nvPr/>
                </p:nvSpPr>
                <p:spPr bwMode="auto">
                  <a:xfrm>
                    <a:off x="4829176" y="5989638"/>
                    <a:ext cx="96838" cy="96520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30" name="Freeform 70"/>
                  <p:cNvSpPr>
                    <a:spLocks/>
                  </p:cNvSpPr>
                  <p:nvPr/>
                </p:nvSpPr>
                <p:spPr bwMode="auto">
                  <a:xfrm>
                    <a:off x="4816476" y="5989638"/>
                    <a:ext cx="123825" cy="965200"/>
                  </a:xfrm>
                  <a:custGeom>
                    <a:avLst/>
                    <a:gdLst>
                      <a:gd name="T0" fmla="*/ 17 w 155"/>
                      <a:gd name="T1" fmla="*/ 1216 h 1216"/>
                      <a:gd name="T2" fmla="*/ 17 w 155"/>
                      <a:gd name="T3" fmla="*/ 0 h 1216"/>
                      <a:gd name="T4" fmla="*/ 0 w 155"/>
                      <a:gd name="T5" fmla="*/ 0 h 1216"/>
                      <a:gd name="T6" fmla="*/ 155 w 155"/>
                      <a:gd name="T7" fmla="*/ 0 h 1216"/>
                      <a:gd name="T8" fmla="*/ 138 w 155"/>
                      <a:gd name="T9" fmla="*/ 0 h 1216"/>
                      <a:gd name="T10" fmla="*/ 138 w 155"/>
                      <a:gd name="T11" fmla="*/ 1216 h 121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5" h="1216">
                        <a:moveTo>
                          <a:pt x="17" y="1216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55" y="0"/>
                        </a:lnTo>
                        <a:lnTo>
                          <a:pt x="138" y="0"/>
                        </a:lnTo>
                        <a:lnTo>
                          <a:pt x="138" y="1216"/>
                        </a:lnTo>
                      </a:path>
                    </a:pathLst>
                  </a:custGeom>
                  <a:noFill/>
                  <a:ln w="2698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31" name="Rectangle 71"/>
                  <p:cNvSpPr>
                    <a:spLocks noChangeArrowheads="1"/>
                  </p:cNvSpPr>
                  <p:nvPr/>
                </p:nvSpPr>
                <p:spPr bwMode="auto">
                  <a:xfrm>
                    <a:off x="3424238" y="7051676"/>
                    <a:ext cx="12700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32" name="Rectangle 72"/>
                  <p:cNvSpPr>
                    <a:spLocks noChangeArrowheads="1"/>
                  </p:cNvSpPr>
                  <p:nvPr/>
                </p:nvSpPr>
                <p:spPr bwMode="auto">
                  <a:xfrm>
                    <a:off x="3797301" y="7051676"/>
                    <a:ext cx="12700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2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33" name="Rectangle 73"/>
                  <p:cNvSpPr>
                    <a:spLocks noChangeArrowheads="1"/>
                  </p:cNvSpPr>
                  <p:nvPr/>
                </p:nvSpPr>
                <p:spPr bwMode="auto">
                  <a:xfrm>
                    <a:off x="4173538" y="7051676"/>
                    <a:ext cx="12700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3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34" name="Rectangle 74"/>
                  <p:cNvSpPr>
                    <a:spLocks noChangeArrowheads="1"/>
                  </p:cNvSpPr>
                  <p:nvPr/>
                </p:nvSpPr>
                <p:spPr bwMode="auto">
                  <a:xfrm>
                    <a:off x="4546601" y="7051676"/>
                    <a:ext cx="12700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4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35" name="Rectangle 75"/>
                  <p:cNvSpPr>
                    <a:spLocks noChangeArrowheads="1"/>
                  </p:cNvSpPr>
                  <p:nvPr/>
                </p:nvSpPr>
                <p:spPr bwMode="auto">
                  <a:xfrm>
                    <a:off x="4919663" y="7051676"/>
                    <a:ext cx="12700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5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36" name="Line 76"/>
                  <p:cNvSpPr>
                    <a:spLocks noChangeShapeType="1"/>
                  </p:cNvSpPr>
                  <p:nvPr/>
                </p:nvSpPr>
                <p:spPr bwMode="auto">
                  <a:xfrm>
                    <a:off x="3249613" y="6954838"/>
                    <a:ext cx="1920875" cy="0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37" name="Line 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59163" y="6954838"/>
                    <a:ext cx="0" cy="77788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38" name="Line 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833813" y="6954838"/>
                    <a:ext cx="0" cy="77788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39" name="Line 7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208463" y="6954838"/>
                    <a:ext cx="0" cy="77788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0" name="Line 8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581526" y="6954838"/>
                    <a:ext cx="0" cy="77788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1" name="Line 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954588" y="6954838"/>
                    <a:ext cx="0" cy="77788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2" name="Rectangle 82"/>
                  <p:cNvSpPr>
                    <a:spLocks noChangeArrowheads="1"/>
                  </p:cNvSpPr>
                  <p:nvPr/>
                </p:nvSpPr>
                <p:spPr bwMode="auto">
                  <a:xfrm>
                    <a:off x="3092450" y="6884988"/>
                    <a:ext cx="12700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0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43" name="Rectangle 83"/>
                  <p:cNvSpPr>
                    <a:spLocks noChangeArrowheads="1"/>
                  </p:cNvSpPr>
                  <p:nvPr/>
                </p:nvSpPr>
                <p:spPr bwMode="auto">
                  <a:xfrm>
                    <a:off x="3022600" y="6664326"/>
                    <a:ext cx="19685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20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44" name="Rectangle 84"/>
                  <p:cNvSpPr>
                    <a:spLocks noChangeArrowheads="1"/>
                  </p:cNvSpPr>
                  <p:nvPr/>
                </p:nvSpPr>
                <p:spPr bwMode="auto">
                  <a:xfrm>
                    <a:off x="3022600" y="6442076"/>
                    <a:ext cx="19685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40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45" name="Rectangle 85"/>
                  <p:cNvSpPr>
                    <a:spLocks noChangeArrowheads="1"/>
                  </p:cNvSpPr>
                  <p:nvPr/>
                </p:nvSpPr>
                <p:spPr bwMode="auto">
                  <a:xfrm>
                    <a:off x="3022600" y="6221413"/>
                    <a:ext cx="19685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60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Rectangle 86"/>
                  <p:cNvSpPr>
                    <a:spLocks noChangeArrowheads="1"/>
                  </p:cNvSpPr>
                  <p:nvPr/>
                </p:nvSpPr>
                <p:spPr bwMode="auto">
                  <a:xfrm>
                    <a:off x="3022600" y="6000751"/>
                    <a:ext cx="19685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80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47" name="Rectangle 87"/>
                  <p:cNvSpPr>
                    <a:spLocks noChangeArrowheads="1"/>
                  </p:cNvSpPr>
                  <p:nvPr/>
                </p:nvSpPr>
                <p:spPr bwMode="auto">
                  <a:xfrm>
                    <a:off x="2952750" y="5778501"/>
                    <a:ext cx="266700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00</a:t>
                    </a:r>
                    <a:endParaRPr kumimoji="0" lang="en-US" altLang="en-U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Line 8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259138" y="5838826"/>
                    <a:ext cx="0" cy="1125538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9" name="Line 8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81350" y="6954838"/>
                    <a:ext cx="77788" cy="0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0" name="Line 9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81350" y="6734176"/>
                    <a:ext cx="77788" cy="0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1" name="Line 9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81350" y="6513513"/>
                    <a:ext cx="77788" cy="0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2" name="Line 9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81350" y="6291263"/>
                    <a:ext cx="77788" cy="0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3" name="Line 9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81350" y="6070601"/>
                    <a:ext cx="77788" cy="0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4" name="Line 9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81350" y="5848351"/>
                    <a:ext cx="77788" cy="0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5" name="Freeform 95"/>
                  <p:cNvSpPr>
                    <a:spLocks/>
                  </p:cNvSpPr>
                  <p:nvPr/>
                </p:nvSpPr>
                <p:spPr bwMode="auto">
                  <a:xfrm>
                    <a:off x="3508376" y="6040438"/>
                    <a:ext cx="60325" cy="7938"/>
                  </a:xfrm>
                  <a:custGeom>
                    <a:avLst/>
                    <a:gdLst>
                      <a:gd name="T0" fmla="*/ 0 w 77"/>
                      <a:gd name="T1" fmla="*/ 0 h 9"/>
                      <a:gd name="T2" fmla="*/ 77 w 77"/>
                      <a:gd name="T3" fmla="*/ 0 h 9"/>
                      <a:gd name="T4" fmla="*/ 39 w 77"/>
                      <a:gd name="T5" fmla="*/ 0 h 9"/>
                      <a:gd name="T6" fmla="*/ 39 w 77"/>
                      <a:gd name="T7" fmla="*/ 9 h 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77" h="9">
                        <a:moveTo>
                          <a:pt x="0" y="0"/>
                        </a:moveTo>
                        <a:lnTo>
                          <a:pt x="77" y="0"/>
                        </a:lnTo>
                        <a:lnTo>
                          <a:pt x="39" y="0"/>
                        </a:lnTo>
                        <a:lnTo>
                          <a:pt x="39" y="9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6" name="Freeform 96"/>
                  <p:cNvSpPr>
                    <a:spLocks/>
                  </p:cNvSpPr>
                  <p:nvPr/>
                </p:nvSpPr>
                <p:spPr bwMode="auto">
                  <a:xfrm>
                    <a:off x="3881438" y="6051551"/>
                    <a:ext cx="61913" cy="6350"/>
                  </a:xfrm>
                  <a:custGeom>
                    <a:avLst/>
                    <a:gdLst>
                      <a:gd name="T0" fmla="*/ 0 w 76"/>
                      <a:gd name="T1" fmla="*/ 0 h 8"/>
                      <a:gd name="T2" fmla="*/ 76 w 76"/>
                      <a:gd name="T3" fmla="*/ 0 h 8"/>
                      <a:gd name="T4" fmla="*/ 38 w 76"/>
                      <a:gd name="T5" fmla="*/ 0 h 8"/>
                      <a:gd name="T6" fmla="*/ 38 w 76"/>
                      <a:gd name="T7" fmla="*/ 8 h 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76" h="8">
                        <a:moveTo>
                          <a:pt x="0" y="0"/>
                        </a:moveTo>
                        <a:lnTo>
                          <a:pt x="76" y="0"/>
                        </a:lnTo>
                        <a:lnTo>
                          <a:pt x="38" y="0"/>
                        </a:lnTo>
                        <a:lnTo>
                          <a:pt x="38" y="8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7" name="Freeform 97"/>
                  <p:cNvSpPr>
                    <a:spLocks/>
                  </p:cNvSpPr>
                  <p:nvPr/>
                </p:nvSpPr>
                <p:spPr bwMode="auto">
                  <a:xfrm>
                    <a:off x="4629151" y="5986463"/>
                    <a:ext cx="60325" cy="1588"/>
                  </a:xfrm>
                  <a:custGeom>
                    <a:avLst/>
                    <a:gdLst>
                      <a:gd name="T0" fmla="*/ 0 w 77"/>
                      <a:gd name="T1" fmla="*/ 0 h 2"/>
                      <a:gd name="T2" fmla="*/ 77 w 77"/>
                      <a:gd name="T3" fmla="*/ 0 h 2"/>
                      <a:gd name="T4" fmla="*/ 39 w 77"/>
                      <a:gd name="T5" fmla="*/ 0 h 2"/>
                      <a:gd name="T6" fmla="*/ 39 w 77"/>
                      <a:gd name="T7" fmla="*/ 2 h 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77" h="2">
                        <a:moveTo>
                          <a:pt x="0" y="0"/>
                        </a:moveTo>
                        <a:lnTo>
                          <a:pt x="77" y="0"/>
                        </a:lnTo>
                        <a:lnTo>
                          <a:pt x="39" y="0"/>
                        </a:lnTo>
                        <a:lnTo>
                          <a:pt x="39" y="2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8" name="Freeform 98"/>
                  <p:cNvSpPr>
                    <a:spLocks/>
                  </p:cNvSpPr>
                  <p:nvPr/>
                </p:nvSpPr>
                <p:spPr bwMode="auto">
                  <a:xfrm>
                    <a:off x="5002213" y="5964238"/>
                    <a:ext cx="60325" cy="1588"/>
                  </a:xfrm>
                  <a:custGeom>
                    <a:avLst/>
                    <a:gdLst>
                      <a:gd name="T0" fmla="*/ 0 w 77"/>
                      <a:gd name="T1" fmla="*/ 0 h 1"/>
                      <a:gd name="T2" fmla="*/ 77 w 77"/>
                      <a:gd name="T3" fmla="*/ 0 h 1"/>
                      <a:gd name="T4" fmla="*/ 38 w 77"/>
                      <a:gd name="T5" fmla="*/ 0 h 1"/>
                      <a:gd name="T6" fmla="*/ 38 w 77"/>
                      <a:gd name="T7" fmla="*/ 1 h 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77" h="1">
                        <a:moveTo>
                          <a:pt x="0" y="0"/>
                        </a:moveTo>
                        <a:lnTo>
                          <a:pt x="77" y="0"/>
                        </a:lnTo>
                        <a:lnTo>
                          <a:pt x="38" y="0"/>
                        </a:lnTo>
                        <a:lnTo>
                          <a:pt x="38" y="1"/>
                        </a:lnTo>
                      </a:path>
                    </a:pathLst>
                  </a:cu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9" name="Rectangle 99"/>
                  <p:cNvSpPr>
                    <a:spLocks noChangeArrowheads="1"/>
                  </p:cNvSpPr>
                  <p:nvPr/>
                </p:nvSpPr>
                <p:spPr bwMode="auto">
                  <a:xfrm>
                    <a:off x="3960813" y="7279491"/>
                    <a:ext cx="582613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Recipient</a:t>
                    </a:r>
                    <a:endParaRPr kumimoji="0" lang="en-US" altLang="en-U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66" name="Rectangle 106"/>
                  <p:cNvSpPr>
                    <a:spLocks noChangeArrowheads="1"/>
                  </p:cNvSpPr>
                  <p:nvPr/>
                </p:nvSpPr>
                <p:spPr bwMode="auto">
                  <a:xfrm>
                    <a:off x="3996531" y="5585018"/>
                    <a:ext cx="423863" cy="1682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T cells</a:t>
                    </a:r>
                    <a:endParaRPr kumimoji="0" lang="en-US" altLang="en-U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71" name="TextBox 170"/>
                <p:cNvSpPr txBox="1"/>
                <p:nvPr/>
              </p:nvSpPr>
              <p:spPr>
                <a:xfrm rot="16200000">
                  <a:off x="2234943" y="6278446"/>
                  <a:ext cx="12947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ercent live CD3+ 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174" name="TextBox 173"/>
          <p:cNvSpPr txBox="1"/>
          <p:nvPr/>
        </p:nvSpPr>
        <p:spPr>
          <a:xfrm>
            <a:off x="248584" y="61198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dirty="0"/>
          </a:p>
        </p:txBody>
      </p:sp>
      <p:sp>
        <p:nvSpPr>
          <p:cNvPr id="175" name="TextBox 174"/>
          <p:cNvSpPr txBox="1"/>
          <p:nvPr/>
        </p:nvSpPr>
        <p:spPr>
          <a:xfrm>
            <a:off x="2982059" y="612418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0916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175</Words>
  <Application>Microsoft Office PowerPoint</Application>
  <PresentationFormat>Letter Paper (8.5x11 in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ia Vojtech</dc:creator>
  <cp:lastModifiedBy>Lucia Vojtech</cp:lastModifiedBy>
  <cp:revision>10</cp:revision>
  <dcterms:created xsi:type="dcterms:W3CDTF">2019-08-07T02:59:11Z</dcterms:created>
  <dcterms:modified xsi:type="dcterms:W3CDTF">2019-08-12T20:41:57Z</dcterms:modified>
</cp:coreProperties>
</file>